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11"/>
  </p:normalViewPr>
  <p:slideViewPr>
    <p:cSldViewPr>
      <p:cViewPr>
        <p:scale>
          <a:sx n="150" d="100"/>
          <a:sy n="150" d="100"/>
        </p:scale>
        <p:origin x="1600" y="-36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01403060\Desktop\Revised%20Figures%20Plant%20J\Fig%20S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01403060\Desktop\Revised%20Figures%20Plant%20J\Fig%20S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01403060\Desktop\Revised%20Figures%20Plant%20J\Fig%20S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01403060\Desktop\Revised%20Figures%20Plant%20J\Fig%20S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Infected</c:v>
                </c:pt>
              </c:strCache>
            </c:strRef>
          </c:tx>
          <c:spPr>
            <a:ln w="25400">
              <a:noFill/>
            </a:ln>
          </c:spPr>
          <c:marker>
            <c:symbol val="diamond"/>
            <c:size val="8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2:$I$2</c:f>
                <c:numCache>
                  <c:formatCode>General</c:formatCode>
                  <c:ptCount val="4"/>
                  <c:pt idx="0">
                    <c:v>0.0280721392131058</c:v>
                  </c:pt>
                  <c:pt idx="1">
                    <c:v>0.056639253173043</c:v>
                  </c:pt>
                  <c:pt idx="2">
                    <c:v>0.0241123412384603</c:v>
                  </c:pt>
                  <c:pt idx="3">
                    <c:v>0.0602454977570929</c:v>
                  </c:pt>
                </c:numCache>
              </c:numRef>
            </c:plus>
            <c:minus>
              <c:numRef>
                <c:f>Sheet1!$F$2:$I$2</c:f>
                <c:numCache>
                  <c:formatCode>General</c:formatCode>
                  <c:ptCount val="4"/>
                  <c:pt idx="0">
                    <c:v>0.0280721392131058</c:v>
                  </c:pt>
                  <c:pt idx="1">
                    <c:v>0.056639253173043</c:v>
                  </c:pt>
                  <c:pt idx="2">
                    <c:v>0.0241123412384603</c:v>
                  </c:pt>
                  <c:pt idx="3">
                    <c:v>0.0602454977570929</c:v>
                  </c:pt>
                </c:numCache>
              </c:numRef>
            </c:minus>
          </c:errBars>
          <c:xVal>
            <c:strRef>
              <c:f>Sheet1!$B$1:$E$1</c:f>
              <c:strCache>
                <c:ptCount val="4"/>
                <c:pt idx="0">
                  <c:v>dawn_18</c:v>
                </c:pt>
                <c:pt idx="1">
                  <c:v>dawn_22</c:v>
                </c:pt>
                <c:pt idx="2">
                  <c:v>night_18</c:v>
                </c:pt>
                <c:pt idx="3">
                  <c:v>night_22</c:v>
                </c:pt>
              </c:strCache>
            </c:strRef>
          </c:xVal>
          <c:yVal>
            <c:numRef>
              <c:f>Sheet1!$B$2:$E$2</c:f>
              <c:numCache>
                <c:formatCode>General</c:formatCode>
                <c:ptCount val="4"/>
                <c:pt idx="0">
                  <c:v>8.32985</c:v>
                </c:pt>
                <c:pt idx="1">
                  <c:v>8.032050000000003</c:v>
                </c:pt>
                <c:pt idx="2">
                  <c:v>8.86585</c:v>
                </c:pt>
                <c:pt idx="3">
                  <c:v>8.67640000000000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Mock</c:v>
                </c:pt>
              </c:strCache>
            </c:strRef>
          </c:tx>
          <c:spPr>
            <a:ln w="25400">
              <a:noFill/>
            </a:ln>
          </c:spPr>
          <c:marker>
            <c:symbol val="circle"/>
            <c:size val="8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3:$I$3</c:f>
                <c:numCache>
                  <c:formatCode>General</c:formatCode>
                  <c:ptCount val="4"/>
                  <c:pt idx="0">
                    <c:v>0.0130814754519508</c:v>
                  </c:pt>
                  <c:pt idx="1">
                    <c:v>0.0190918830920362</c:v>
                  </c:pt>
                  <c:pt idx="2">
                    <c:v>0.0127279220613583</c:v>
                  </c:pt>
                  <c:pt idx="3">
                    <c:v>0.022556706319851</c:v>
                  </c:pt>
                </c:numCache>
              </c:numRef>
            </c:plus>
            <c:minus>
              <c:numRef>
                <c:f>Sheet1!$F$3:$I$3</c:f>
                <c:numCache>
                  <c:formatCode>General</c:formatCode>
                  <c:ptCount val="4"/>
                  <c:pt idx="0">
                    <c:v>0.0130814754519508</c:v>
                  </c:pt>
                  <c:pt idx="1">
                    <c:v>0.0190918830920362</c:v>
                  </c:pt>
                  <c:pt idx="2">
                    <c:v>0.0127279220613583</c:v>
                  </c:pt>
                  <c:pt idx="3">
                    <c:v>0.022556706319851</c:v>
                  </c:pt>
                </c:numCache>
              </c:numRef>
            </c:minus>
          </c:errBars>
          <c:xVal>
            <c:strRef>
              <c:f>Sheet1!$B$1:$E$1</c:f>
              <c:strCache>
                <c:ptCount val="4"/>
                <c:pt idx="0">
                  <c:v>dawn_18</c:v>
                </c:pt>
                <c:pt idx="1">
                  <c:v>dawn_22</c:v>
                </c:pt>
                <c:pt idx="2">
                  <c:v>night_18</c:v>
                </c:pt>
                <c:pt idx="3">
                  <c:v>night_22</c:v>
                </c:pt>
              </c:strCache>
            </c:strRef>
          </c:xVal>
          <c:yVal>
            <c:numRef>
              <c:f>Sheet1!$B$3:$E$3</c:f>
              <c:numCache>
                <c:formatCode>General</c:formatCode>
                <c:ptCount val="4"/>
                <c:pt idx="0">
                  <c:v>9.09815</c:v>
                </c:pt>
                <c:pt idx="1">
                  <c:v>8.853900000000002</c:v>
                </c:pt>
                <c:pt idx="2">
                  <c:v>9.3901</c:v>
                </c:pt>
                <c:pt idx="3">
                  <c:v>9.06585000000000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92697904"/>
        <c:axId val="-2092694944"/>
      </c:scatterChart>
      <c:valAx>
        <c:axId val="-2092697904"/>
        <c:scaling>
          <c:orientation val="minMax"/>
        </c:scaling>
        <c:delete val="1"/>
        <c:axPos val="b"/>
        <c:majorTickMark val="out"/>
        <c:minorTickMark val="none"/>
        <c:tickLblPos val="nextTo"/>
        <c:crossAx val="-2092694944"/>
        <c:crosses val="autoZero"/>
        <c:crossBetween val="midCat"/>
      </c:valAx>
      <c:valAx>
        <c:axId val="-2092694944"/>
        <c:scaling>
          <c:orientation val="minMax"/>
          <c:max val="10.0"/>
          <c:min val="7.0"/>
        </c:scaling>
        <c:delete val="0"/>
        <c:axPos val="l"/>
        <c:majorGridlines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092697904"/>
        <c:crosses val="autoZero"/>
        <c:crossBetween val="midCat"/>
        <c:majorUnit val="1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A$23</c:f>
              <c:strCache>
                <c:ptCount val="1"/>
                <c:pt idx="0">
                  <c:v>infected</c:v>
                </c:pt>
              </c:strCache>
            </c:strRef>
          </c:tx>
          <c:spPr>
            <a:ln w="25400">
              <a:noFill/>
            </a:ln>
          </c:spPr>
          <c:marker>
            <c:symbol val="diamond"/>
            <c:size val="8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23:$I$23</c:f>
                <c:numCache>
                  <c:formatCode>General</c:formatCode>
                  <c:ptCount val="4"/>
                  <c:pt idx="0">
                    <c:v>0.0979342891943359</c:v>
                  </c:pt>
                  <c:pt idx="1">
                    <c:v>0.0367695526217002</c:v>
                  </c:pt>
                  <c:pt idx="2">
                    <c:v>0.100267741572252</c:v>
                  </c:pt>
                  <c:pt idx="3">
                    <c:v>0.0134350288425432</c:v>
                  </c:pt>
                </c:numCache>
              </c:numRef>
            </c:plus>
            <c:minus>
              <c:numRef>
                <c:f>Sheet1!$F$23:$I$23</c:f>
                <c:numCache>
                  <c:formatCode>General</c:formatCode>
                  <c:ptCount val="4"/>
                  <c:pt idx="0">
                    <c:v>0.0979342891943359</c:v>
                  </c:pt>
                  <c:pt idx="1">
                    <c:v>0.0367695526217002</c:v>
                  </c:pt>
                  <c:pt idx="2">
                    <c:v>0.100267741572252</c:v>
                  </c:pt>
                  <c:pt idx="3">
                    <c:v>0.0134350288425432</c:v>
                  </c:pt>
                </c:numCache>
              </c:numRef>
            </c:minus>
          </c:errBars>
          <c:xVal>
            <c:strRef>
              <c:f>Sheet1!$B$22:$E$22</c:f>
              <c:strCache>
                <c:ptCount val="4"/>
                <c:pt idx="0">
                  <c:v>dawn_18</c:v>
                </c:pt>
                <c:pt idx="1">
                  <c:v>dawn_22</c:v>
                </c:pt>
                <c:pt idx="2">
                  <c:v>night_18</c:v>
                </c:pt>
                <c:pt idx="3">
                  <c:v>night_22</c:v>
                </c:pt>
              </c:strCache>
            </c:strRef>
          </c:xVal>
          <c:yVal>
            <c:numRef>
              <c:f>Sheet1!$B$23:$E$23</c:f>
              <c:numCache>
                <c:formatCode>General</c:formatCode>
                <c:ptCount val="4"/>
                <c:pt idx="0">
                  <c:v>10.79925</c:v>
                </c:pt>
                <c:pt idx="1">
                  <c:v>11.366</c:v>
                </c:pt>
                <c:pt idx="2">
                  <c:v>9.5554</c:v>
                </c:pt>
                <c:pt idx="3">
                  <c:v>10.746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A$24</c:f>
              <c:strCache>
                <c:ptCount val="1"/>
                <c:pt idx="0">
                  <c:v>mock</c:v>
                </c:pt>
              </c:strCache>
            </c:strRef>
          </c:tx>
          <c:spPr>
            <a:ln w="25400">
              <a:noFill/>
            </a:ln>
          </c:spPr>
          <c:marker>
            <c:symbol val="circle"/>
            <c:size val="8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24:$I$24</c:f>
                <c:numCache>
                  <c:formatCode>General</c:formatCode>
                  <c:ptCount val="4"/>
                  <c:pt idx="0">
                    <c:v>0.022980970388562</c:v>
                  </c:pt>
                  <c:pt idx="1">
                    <c:v>0.0417193000900058</c:v>
                  </c:pt>
                  <c:pt idx="2">
                    <c:v>0.0457498087427698</c:v>
                  </c:pt>
                  <c:pt idx="3">
                    <c:v>0.0770039284712152</c:v>
                  </c:pt>
                </c:numCache>
              </c:numRef>
            </c:plus>
            <c:minus>
              <c:numRef>
                <c:f>Sheet1!$F$24:$I$24</c:f>
                <c:numCache>
                  <c:formatCode>General</c:formatCode>
                  <c:ptCount val="4"/>
                  <c:pt idx="0">
                    <c:v>0.022980970388562</c:v>
                  </c:pt>
                  <c:pt idx="1">
                    <c:v>0.0417193000900058</c:v>
                  </c:pt>
                  <c:pt idx="2">
                    <c:v>0.0457498087427698</c:v>
                  </c:pt>
                  <c:pt idx="3">
                    <c:v>0.0770039284712152</c:v>
                  </c:pt>
                </c:numCache>
              </c:numRef>
            </c:minus>
          </c:errBars>
          <c:xVal>
            <c:strRef>
              <c:f>Sheet1!$B$22:$E$22</c:f>
              <c:strCache>
                <c:ptCount val="4"/>
                <c:pt idx="0">
                  <c:v>dawn_18</c:v>
                </c:pt>
                <c:pt idx="1">
                  <c:v>dawn_22</c:v>
                </c:pt>
                <c:pt idx="2">
                  <c:v>night_18</c:v>
                </c:pt>
                <c:pt idx="3">
                  <c:v>night_22</c:v>
                </c:pt>
              </c:strCache>
            </c:strRef>
          </c:xVal>
          <c:yVal>
            <c:numRef>
              <c:f>Sheet1!$B$24:$E$24</c:f>
              <c:numCache>
                <c:formatCode>General</c:formatCode>
                <c:ptCount val="4"/>
                <c:pt idx="0">
                  <c:v>9.37335</c:v>
                </c:pt>
                <c:pt idx="1">
                  <c:v>9.828900000000001</c:v>
                </c:pt>
                <c:pt idx="2">
                  <c:v>8.166550000000002</c:v>
                </c:pt>
                <c:pt idx="3">
                  <c:v>8.75585000000000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92663184"/>
        <c:axId val="-2092660224"/>
      </c:scatterChart>
      <c:valAx>
        <c:axId val="-2092663184"/>
        <c:scaling>
          <c:orientation val="minMax"/>
        </c:scaling>
        <c:delete val="1"/>
        <c:axPos val="b"/>
        <c:majorTickMark val="out"/>
        <c:minorTickMark val="none"/>
        <c:tickLblPos val="nextTo"/>
        <c:crossAx val="-2092660224"/>
        <c:crosses val="autoZero"/>
        <c:crossBetween val="midCat"/>
      </c:valAx>
      <c:valAx>
        <c:axId val="-2092660224"/>
        <c:scaling>
          <c:orientation val="minMax"/>
          <c:max val="12.0"/>
          <c:min val="8.0"/>
        </c:scaling>
        <c:delete val="0"/>
        <c:axPos val="l"/>
        <c:majorGridlines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092663184"/>
        <c:crosses val="autoZero"/>
        <c:crossBetween val="midCat"/>
        <c:majorUnit val="1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A$42</c:f>
              <c:strCache>
                <c:ptCount val="1"/>
                <c:pt idx="0">
                  <c:v>infected</c:v>
                </c:pt>
              </c:strCache>
            </c:strRef>
          </c:tx>
          <c:spPr>
            <a:ln w="25400">
              <a:noFill/>
            </a:ln>
          </c:spPr>
          <c:marker>
            <c:symbol val="diamond"/>
            <c:size val="8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42:$I$42</c:f>
                <c:numCache>
                  <c:formatCode>General</c:formatCode>
                  <c:ptCount val="4"/>
                  <c:pt idx="0">
                    <c:v>0.00791959594928846</c:v>
                  </c:pt>
                  <c:pt idx="1">
                    <c:v>0.0459619407771252</c:v>
                  </c:pt>
                  <c:pt idx="2">
                    <c:v>0.0204353859762913</c:v>
                  </c:pt>
                  <c:pt idx="3">
                    <c:v>0.020788939366885</c:v>
                  </c:pt>
                </c:numCache>
              </c:numRef>
            </c:plus>
            <c:minus>
              <c:numRef>
                <c:f>Sheet1!$F$42:$I$42</c:f>
                <c:numCache>
                  <c:formatCode>General</c:formatCode>
                  <c:ptCount val="4"/>
                  <c:pt idx="0">
                    <c:v>0.00791959594928846</c:v>
                  </c:pt>
                  <c:pt idx="1">
                    <c:v>0.0459619407771252</c:v>
                  </c:pt>
                  <c:pt idx="2">
                    <c:v>0.0204353859762913</c:v>
                  </c:pt>
                  <c:pt idx="3">
                    <c:v>0.020788939366885</c:v>
                  </c:pt>
                </c:numCache>
              </c:numRef>
            </c:minus>
          </c:errBars>
          <c:xVal>
            <c:strRef>
              <c:f>Sheet1!$B$41:$E$41</c:f>
              <c:strCache>
                <c:ptCount val="4"/>
                <c:pt idx="0">
                  <c:v>dawn_18</c:v>
                </c:pt>
                <c:pt idx="1">
                  <c:v>dawn_22</c:v>
                </c:pt>
                <c:pt idx="2">
                  <c:v>night_18</c:v>
                </c:pt>
                <c:pt idx="3">
                  <c:v>night_22</c:v>
                </c:pt>
              </c:strCache>
            </c:strRef>
          </c:xVal>
          <c:yVal>
            <c:numRef>
              <c:f>Sheet1!$B$42:$E$42</c:f>
              <c:numCache>
                <c:formatCode>General</c:formatCode>
                <c:ptCount val="4"/>
                <c:pt idx="0">
                  <c:v>10.1165</c:v>
                </c:pt>
                <c:pt idx="1">
                  <c:v>9.433800000000001</c:v>
                </c:pt>
                <c:pt idx="2">
                  <c:v>11.12515</c:v>
                </c:pt>
                <c:pt idx="3">
                  <c:v>9.88300000000000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A$43</c:f>
              <c:strCache>
                <c:ptCount val="1"/>
                <c:pt idx="0">
                  <c:v>mock</c:v>
                </c:pt>
              </c:strCache>
            </c:strRef>
          </c:tx>
          <c:spPr>
            <a:ln w="25400">
              <a:noFill/>
            </a:ln>
          </c:spPr>
          <c:marker>
            <c:symbol val="circle"/>
            <c:size val="8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43:$I$43</c:f>
                <c:numCache>
                  <c:formatCode>General</c:formatCode>
                  <c:ptCount val="4"/>
                  <c:pt idx="0">
                    <c:v>0.061306157928874</c:v>
                  </c:pt>
                  <c:pt idx="1">
                    <c:v>0.0236880771697494</c:v>
                  </c:pt>
                  <c:pt idx="2">
                    <c:v>0.036062445840514</c:v>
                  </c:pt>
                  <c:pt idx="3">
                    <c:v>0.0257386868351894</c:v>
                  </c:pt>
                </c:numCache>
              </c:numRef>
            </c:plus>
            <c:minus>
              <c:numRef>
                <c:f>Sheet1!$F$43:$I$43</c:f>
                <c:numCache>
                  <c:formatCode>General</c:formatCode>
                  <c:ptCount val="4"/>
                  <c:pt idx="0">
                    <c:v>0.061306157928874</c:v>
                  </c:pt>
                  <c:pt idx="1">
                    <c:v>0.0236880771697494</c:v>
                  </c:pt>
                  <c:pt idx="2">
                    <c:v>0.036062445840514</c:v>
                  </c:pt>
                  <c:pt idx="3">
                    <c:v>0.0257386868351894</c:v>
                  </c:pt>
                </c:numCache>
              </c:numRef>
            </c:minus>
          </c:errBars>
          <c:xVal>
            <c:strRef>
              <c:f>Sheet1!$B$41:$E$41</c:f>
              <c:strCache>
                <c:ptCount val="4"/>
                <c:pt idx="0">
                  <c:v>dawn_18</c:v>
                </c:pt>
                <c:pt idx="1">
                  <c:v>dawn_22</c:v>
                </c:pt>
                <c:pt idx="2">
                  <c:v>night_18</c:v>
                </c:pt>
                <c:pt idx="3">
                  <c:v>night_22</c:v>
                </c:pt>
              </c:strCache>
            </c:strRef>
          </c:xVal>
          <c:yVal>
            <c:numRef>
              <c:f>Sheet1!$B$43:$E$43</c:f>
              <c:numCache>
                <c:formatCode>General</c:formatCode>
                <c:ptCount val="4"/>
                <c:pt idx="0">
                  <c:v>12.22415</c:v>
                </c:pt>
                <c:pt idx="1">
                  <c:v>12.33055</c:v>
                </c:pt>
                <c:pt idx="2">
                  <c:v>12.1272</c:v>
                </c:pt>
                <c:pt idx="3">
                  <c:v>12.216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92621040"/>
        <c:axId val="-2092618080"/>
      </c:scatterChart>
      <c:valAx>
        <c:axId val="-2092621040"/>
        <c:scaling>
          <c:orientation val="minMax"/>
        </c:scaling>
        <c:delete val="1"/>
        <c:axPos val="b"/>
        <c:majorTickMark val="out"/>
        <c:minorTickMark val="none"/>
        <c:tickLblPos val="nextTo"/>
        <c:crossAx val="-2092618080"/>
        <c:crosses val="autoZero"/>
        <c:crossBetween val="midCat"/>
      </c:valAx>
      <c:valAx>
        <c:axId val="-2092618080"/>
        <c:scaling>
          <c:orientation val="minMax"/>
          <c:max val="13.0"/>
          <c:min val="9.0"/>
        </c:scaling>
        <c:delete val="0"/>
        <c:axPos val="l"/>
        <c:majorGridlines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092621040"/>
        <c:crosses val="autoZero"/>
        <c:crossBetween val="midCat"/>
        <c:majorUnit val="1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A$61</c:f>
              <c:strCache>
                <c:ptCount val="1"/>
                <c:pt idx="0">
                  <c:v>infecte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8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61:$I$61</c:f>
                <c:numCache>
                  <c:formatCode>General</c:formatCode>
                  <c:ptCount val="4"/>
                  <c:pt idx="0">
                    <c:v>0.0166877200360026</c:v>
                  </c:pt>
                  <c:pt idx="1">
                    <c:v>0.040234375849515</c:v>
                  </c:pt>
                  <c:pt idx="2">
                    <c:v>0.00756604255869601</c:v>
                  </c:pt>
                  <c:pt idx="3">
                    <c:v>0.0291327993848857</c:v>
                  </c:pt>
                </c:numCache>
              </c:numRef>
            </c:plus>
            <c:minus>
              <c:numRef>
                <c:f>Sheet1!$F$61:$I$61</c:f>
                <c:numCache>
                  <c:formatCode>General</c:formatCode>
                  <c:ptCount val="4"/>
                  <c:pt idx="0">
                    <c:v>0.0166877200360026</c:v>
                  </c:pt>
                  <c:pt idx="1">
                    <c:v>0.040234375849515</c:v>
                  </c:pt>
                  <c:pt idx="2">
                    <c:v>0.00756604255869601</c:v>
                  </c:pt>
                  <c:pt idx="3">
                    <c:v>0.0291327993848857</c:v>
                  </c:pt>
                </c:numCache>
              </c:numRef>
            </c:minus>
          </c:errBars>
          <c:xVal>
            <c:strRef>
              <c:f>Sheet1!$B$60:$E$60</c:f>
              <c:strCache>
                <c:ptCount val="4"/>
                <c:pt idx="0">
                  <c:v>dawn_18</c:v>
                </c:pt>
                <c:pt idx="1">
                  <c:v>dawn_22</c:v>
                </c:pt>
                <c:pt idx="2">
                  <c:v>night_18</c:v>
                </c:pt>
                <c:pt idx="3">
                  <c:v>night_22</c:v>
                </c:pt>
              </c:strCache>
            </c:strRef>
          </c:xVal>
          <c:yVal>
            <c:numRef>
              <c:f>Sheet1!$B$61:$E$61</c:f>
              <c:numCache>
                <c:formatCode>General</c:formatCode>
                <c:ptCount val="4"/>
                <c:pt idx="0">
                  <c:v>9.731299999999997</c:v>
                </c:pt>
                <c:pt idx="1">
                  <c:v>10.78325</c:v>
                </c:pt>
                <c:pt idx="2">
                  <c:v>8.92505</c:v>
                </c:pt>
                <c:pt idx="3">
                  <c:v>10.401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A$62</c:f>
              <c:strCache>
                <c:ptCount val="1"/>
                <c:pt idx="0">
                  <c:v>mock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8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62:$I$62</c:f>
                <c:numCache>
                  <c:formatCode>General</c:formatCode>
                  <c:ptCount val="4"/>
                  <c:pt idx="0">
                    <c:v>0.070639967440536</c:v>
                  </c:pt>
                  <c:pt idx="1">
                    <c:v>0.0222031529292574</c:v>
                  </c:pt>
                  <c:pt idx="2">
                    <c:v>0.0135764501987815</c:v>
                  </c:pt>
                  <c:pt idx="3">
                    <c:v>0.0291327993848857</c:v>
                  </c:pt>
                </c:numCache>
              </c:numRef>
            </c:plus>
            <c:minus>
              <c:numRef>
                <c:f>Sheet1!$F$62:$I$62</c:f>
                <c:numCache>
                  <c:formatCode>General</c:formatCode>
                  <c:ptCount val="4"/>
                  <c:pt idx="0">
                    <c:v>0.070639967440536</c:v>
                  </c:pt>
                  <c:pt idx="1">
                    <c:v>0.0222031529292574</c:v>
                  </c:pt>
                  <c:pt idx="2">
                    <c:v>0.0135764501987815</c:v>
                  </c:pt>
                  <c:pt idx="3">
                    <c:v>0.0291327993848857</c:v>
                  </c:pt>
                </c:numCache>
              </c:numRef>
            </c:minus>
          </c:errBars>
          <c:xVal>
            <c:strRef>
              <c:f>Sheet1!$B$60:$E$60</c:f>
              <c:strCache>
                <c:ptCount val="4"/>
                <c:pt idx="0">
                  <c:v>dawn_18</c:v>
                </c:pt>
                <c:pt idx="1">
                  <c:v>dawn_22</c:v>
                </c:pt>
                <c:pt idx="2">
                  <c:v>night_18</c:v>
                </c:pt>
                <c:pt idx="3">
                  <c:v>night_22</c:v>
                </c:pt>
              </c:strCache>
            </c:strRef>
          </c:xVal>
          <c:yVal>
            <c:numRef>
              <c:f>Sheet1!$B$62:$E$62</c:f>
              <c:numCache>
                <c:formatCode>General</c:formatCode>
                <c:ptCount val="4"/>
                <c:pt idx="0">
                  <c:v>8.767050000000001</c:v>
                </c:pt>
                <c:pt idx="1">
                  <c:v>8.5226</c:v>
                </c:pt>
                <c:pt idx="2">
                  <c:v>8.749400000000001</c:v>
                </c:pt>
                <c:pt idx="3">
                  <c:v>8.5527000000000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92576272"/>
        <c:axId val="-2092573312"/>
      </c:scatterChart>
      <c:valAx>
        <c:axId val="-2092576272"/>
        <c:scaling>
          <c:orientation val="minMax"/>
        </c:scaling>
        <c:delete val="1"/>
        <c:axPos val="b"/>
        <c:majorTickMark val="none"/>
        <c:minorTickMark val="none"/>
        <c:tickLblPos val="nextTo"/>
        <c:crossAx val="-2092573312"/>
        <c:crosses val="autoZero"/>
        <c:crossBetween val="midCat"/>
      </c:valAx>
      <c:valAx>
        <c:axId val="-2092573312"/>
        <c:scaling>
          <c:orientation val="minMax"/>
          <c:max val="11.0"/>
          <c:min val="8.0"/>
        </c:scaling>
        <c:delete val="0"/>
        <c:axPos val="l"/>
        <c:majorGridlines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092576272"/>
        <c:crosses val="autoZero"/>
        <c:crossBetween val="midCat"/>
        <c:majorUnit val="1.0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30718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08513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83176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67331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79312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88373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09420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59286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5232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36042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59738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19EAD3-8088-4E97-ADEB-BA26DD53CC4A}" type="datetimeFigureOut">
              <a:rPr lang="en-ZA" smtClean="0"/>
              <a:t>2015/09/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924499-FA5F-44D2-9C31-513C4C2343C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88869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048257" y="3474338"/>
            <a:ext cx="881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NAC048</a:t>
            </a:r>
          </a:p>
        </p:txBody>
      </p:sp>
      <p:cxnSp>
        <p:nvCxnSpPr>
          <p:cNvPr id="12" name="Straight Connector 11"/>
          <p:cNvCxnSpPr/>
          <p:nvPr/>
        </p:nvCxnSpPr>
        <p:spPr>
          <a:xfrm>
            <a:off x="1491751" y="2825774"/>
            <a:ext cx="535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5234308" y="323528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HYH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483538" y="2833018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24	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405486" y="2836212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4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349156" y="25598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290926" y="25598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838812" y="25598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766238" y="25598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-7845" y="1464136"/>
            <a:ext cx="1281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821781" y="323528"/>
            <a:ext cx="7677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GATA20</a:t>
            </a:r>
          </a:p>
        </p:txBody>
      </p:sp>
      <p:cxnSp>
        <p:nvCxnSpPr>
          <p:cNvPr id="29" name="Straight Connector 28"/>
          <p:cNvCxnSpPr/>
          <p:nvPr/>
        </p:nvCxnSpPr>
        <p:spPr>
          <a:xfrm>
            <a:off x="2420655" y="2822600"/>
            <a:ext cx="535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 rot="16200000">
            <a:off x="3101275" y="1461957"/>
            <a:ext cx="1281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</a:p>
        </p:txBody>
      </p:sp>
      <p:sp>
        <p:nvSpPr>
          <p:cNvPr id="39" name="TextBox 38"/>
          <p:cNvSpPr txBox="1"/>
          <p:nvPr/>
        </p:nvSpPr>
        <p:spPr>
          <a:xfrm rot="16200000">
            <a:off x="3099531" y="4676086"/>
            <a:ext cx="1281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891112" y="3474338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KS1</a:t>
            </a:r>
          </a:p>
        </p:txBody>
      </p:sp>
      <p:sp>
        <p:nvSpPr>
          <p:cNvPr id="63" name="TextBox 62"/>
          <p:cNvSpPr txBox="1"/>
          <p:nvPr/>
        </p:nvSpPr>
        <p:spPr>
          <a:xfrm rot="16200000">
            <a:off x="-25388" y="4657036"/>
            <a:ext cx="1281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376088" y="27729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348944" y="333558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4" name="Oval 73"/>
          <p:cNvSpPr>
            <a:spLocks noChangeAspect="1"/>
          </p:cNvSpPr>
          <p:nvPr/>
        </p:nvSpPr>
        <p:spPr>
          <a:xfrm>
            <a:off x="3812083" y="6498612"/>
            <a:ext cx="107999" cy="10799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solidFill>
                <a:srgbClr val="000000"/>
              </a:solidFill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857296" y="6415634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fected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3902002" y="6415633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c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2636912" y="6400775"/>
            <a:ext cx="1873732" cy="332160"/>
          </a:xfrm>
          <a:prstGeom prst="rect">
            <a:avLst/>
          </a:prstGeom>
          <a:noFill/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340776" y="7092280"/>
            <a:ext cx="625657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ementary Figure 3. Differential expression of transcription factor (TF) encoding genes in response to infection at subjective dawn or night under LL conditions</a:t>
            </a:r>
            <a:r>
              <a:rPr lang="en-US" sz="1200" dirty="0"/>
              <a:t>. A) TF genes showing different basal levels of expression at CT24 (dawn) or CT42 (night), but a similar fold change in response to infection and B) TF genes with a different fold change in response to infection at CT24 or CT42 but similar basal levels. </a:t>
            </a:r>
            <a:r>
              <a:rPr lang="en-US" sz="1200" dirty="0" smtClean="0"/>
              <a:t>Diamonds and circles are </a:t>
            </a:r>
            <a:r>
              <a:rPr lang="en-US" sz="1200" dirty="0"/>
              <a:t>expression </a:t>
            </a:r>
            <a:r>
              <a:rPr lang="en-US" sz="1200" dirty="0" smtClean="0"/>
              <a:t>values from microarrays (±SD of pooled technical replicates) </a:t>
            </a:r>
            <a:r>
              <a:rPr lang="en-US" sz="1200" dirty="0"/>
              <a:t>after </a:t>
            </a:r>
            <a:r>
              <a:rPr lang="en-US" sz="1200" i="1" dirty="0"/>
              <a:t>B. cinerea </a:t>
            </a:r>
            <a:r>
              <a:rPr lang="en-US" sz="1200" dirty="0"/>
              <a:t>infection and </a:t>
            </a:r>
            <a:r>
              <a:rPr lang="en-US" sz="1200" dirty="0" smtClean="0"/>
              <a:t>mock inoculation respectively. </a:t>
            </a:r>
            <a:endParaRPr lang="en-US" sz="1200" dirty="0"/>
          </a:p>
        </p:txBody>
      </p:sp>
      <p:graphicFrame>
        <p:nvGraphicFramePr>
          <p:cNvPr id="90" name="Chart 8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5330656"/>
              </p:ext>
            </p:extLst>
          </p:nvPr>
        </p:nvGraphicFramePr>
        <p:xfrm>
          <a:off x="763964" y="611561"/>
          <a:ext cx="2771028" cy="19932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1" name="Chart 9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67647342"/>
              </p:ext>
            </p:extLst>
          </p:nvPr>
        </p:nvGraphicFramePr>
        <p:xfrm>
          <a:off x="3931545" y="600527"/>
          <a:ext cx="2772000" cy="199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00" name="Straight Connector 99"/>
          <p:cNvCxnSpPr/>
          <p:nvPr/>
        </p:nvCxnSpPr>
        <p:spPr>
          <a:xfrm>
            <a:off x="4683703" y="2828009"/>
            <a:ext cx="535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1" name="TextBox 100"/>
          <p:cNvSpPr txBox="1"/>
          <p:nvPr/>
        </p:nvSpPr>
        <p:spPr>
          <a:xfrm>
            <a:off x="4675490" y="2835253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24	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597438" y="2838447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4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4541108" y="25621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5482878" y="25621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5030764" y="25621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5958190" y="25621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cxnSp>
        <p:nvCxnSpPr>
          <p:cNvPr id="107" name="Straight Connector 106"/>
          <p:cNvCxnSpPr/>
          <p:nvPr/>
        </p:nvCxnSpPr>
        <p:spPr>
          <a:xfrm>
            <a:off x="5612607" y="2824835"/>
            <a:ext cx="535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108" name="Chart 10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7552260"/>
              </p:ext>
            </p:extLst>
          </p:nvPr>
        </p:nvGraphicFramePr>
        <p:xfrm>
          <a:off x="724531" y="3800534"/>
          <a:ext cx="2772000" cy="199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109" name="Straight Connector 108"/>
          <p:cNvCxnSpPr/>
          <p:nvPr/>
        </p:nvCxnSpPr>
        <p:spPr>
          <a:xfrm>
            <a:off x="1492888" y="6022280"/>
            <a:ext cx="535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1484675" y="6029524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24	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2406623" y="6032718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4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350293" y="57563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2292063" y="57563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1839949" y="57563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2767375" y="57563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cxnSp>
        <p:nvCxnSpPr>
          <p:cNvPr id="116" name="Straight Connector 115"/>
          <p:cNvCxnSpPr/>
          <p:nvPr/>
        </p:nvCxnSpPr>
        <p:spPr>
          <a:xfrm>
            <a:off x="2421792" y="6019106"/>
            <a:ext cx="535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Diamond 1"/>
          <p:cNvSpPr/>
          <p:nvPr/>
        </p:nvSpPr>
        <p:spPr>
          <a:xfrm>
            <a:off x="2761987" y="6490474"/>
            <a:ext cx="134382" cy="126325"/>
          </a:xfrm>
          <a:prstGeom prst="diamond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graphicFrame>
        <p:nvGraphicFramePr>
          <p:cNvPr id="118" name="Chart 1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5000054"/>
              </p:ext>
            </p:extLst>
          </p:nvPr>
        </p:nvGraphicFramePr>
        <p:xfrm>
          <a:off x="3920082" y="3798335"/>
          <a:ext cx="2772000" cy="199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119" name="Straight Connector 118"/>
          <p:cNvCxnSpPr/>
          <p:nvPr/>
        </p:nvCxnSpPr>
        <p:spPr>
          <a:xfrm>
            <a:off x="4684720" y="6028111"/>
            <a:ext cx="535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0" name="TextBox 119"/>
          <p:cNvSpPr txBox="1"/>
          <p:nvPr/>
        </p:nvSpPr>
        <p:spPr>
          <a:xfrm>
            <a:off x="4676507" y="6035355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24	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5598455" y="6038549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T4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4542125" y="57622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5483895" y="57622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5031781" y="57622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5959207" y="57622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cxnSp>
        <p:nvCxnSpPr>
          <p:cNvPr id="126" name="Straight Connector 125"/>
          <p:cNvCxnSpPr/>
          <p:nvPr/>
        </p:nvCxnSpPr>
        <p:spPr>
          <a:xfrm>
            <a:off x="5613624" y="6024937"/>
            <a:ext cx="535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7" name="Rectangle 126"/>
          <p:cNvSpPr/>
          <p:nvPr/>
        </p:nvSpPr>
        <p:spPr>
          <a:xfrm>
            <a:off x="1105694" y="749418"/>
            <a:ext cx="1152000" cy="1699200"/>
          </a:xfrm>
          <a:prstGeom prst="rect">
            <a:avLst/>
          </a:prstGeom>
          <a:solidFill>
            <a:schemeClr val="bg1">
              <a:lumMod val="95000"/>
              <a:alpha val="9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Rectangle 127"/>
          <p:cNvSpPr/>
          <p:nvPr/>
        </p:nvSpPr>
        <p:spPr>
          <a:xfrm>
            <a:off x="2267346" y="756843"/>
            <a:ext cx="1152000" cy="1699200"/>
          </a:xfrm>
          <a:prstGeom prst="rect">
            <a:avLst/>
          </a:prstGeom>
          <a:solidFill>
            <a:schemeClr val="bg1">
              <a:lumMod val="65000"/>
              <a:alpha val="2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Rectangle 130"/>
          <p:cNvSpPr/>
          <p:nvPr/>
        </p:nvSpPr>
        <p:spPr>
          <a:xfrm>
            <a:off x="4274175" y="746051"/>
            <a:ext cx="1152000" cy="1699200"/>
          </a:xfrm>
          <a:prstGeom prst="rect">
            <a:avLst/>
          </a:prstGeom>
          <a:solidFill>
            <a:schemeClr val="bg1">
              <a:lumMod val="95000"/>
              <a:alpha val="9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Rectangle 131"/>
          <p:cNvSpPr/>
          <p:nvPr/>
        </p:nvSpPr>
        <p:spPr>
          <a:xfrm>
            <a:off x="5435827" y="753476"/>
            <a:ext cx="1152000" cy="1699200"/>
          </a:xfrm>
          <a:prstGeom prst="rect">
            <a:avLst/>
          </a:prstGeom>
          <a:solidFill>
            <a:schemeClr val="bg1">
              <a:lumMod val="65000"/>
              <a:alpha val="2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3" name="Rectangle 132"/>
          <p:cNvSpPr/>
          <p:nvPr/>
        </p:nvSpPr>
        <p:spPr>
          <a:xfrm>
            <a:off x="1052736" y="3935970"/>
            <a:ext cx="1152000" cy="1699200"/>
          </a:xfrm>
          <a:prstGeom prst="rect">
            <a:avLst/>
          </a:prstGeom>
          <a:solidFill>
            <a:schemeClr val="bg1">
              <a:lumMod val="95000"/>
              <a:alpha val="9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4" name="Rectangle 133"/>
          <p:cNvSpPr/>
          <p:nvPr/>
        </p:nvSpPr>
        <p:spPr>
          <a:xfrm>
            <a:off x="2214388" y="3943395"/>
            <a:ext cx="1152000" cy="1699200"/>
          </a:xfrm>
          <a:prstGeom prst="rect">
            <a:avLst/>
          </a:prstGeom>
          <a:solidFill>
            <a:schemeClr val="bg1">
              <a:lumMod val="65000"/>
              <a:alpha val="2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Rectangle 134"/>
          <p:cNvSpPr/>
          <p:nvPr/>
        </p:nvSpPr>
        <p:spPr>
          <a:xfrm>
            <a:off x="4264521" y="3935970"/>
            <a:ext cx="1152000" cy="1699200"/>
          </a:xfrm>
          <a:prstGeom prst="rect">
            <a:avLst/>
          </a:prstGeom>
          <a:solidFill>
            <a:schemeClr val="bg1">
              <a:lumMod val="95000"/>
              <a:alpha val="9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Rectangle 135"/>
          <p:cNvSpPr/>
          <p:nvPr/>
        </p:nvSpPr>
        <p:spPr>
          <a:xfrm>
            <a:off x="5426173" y="3943395"/>
            <a:ext cx="1152000" cy="1699200"/>
          </a:xfrm>
          <a:prstGeom prst="rect">
            <a:avLst/>
          </a:prstGeom>
          <a:solidFill>
            <a:schemeClr val="bg1">
              <a:lumMod val="65000"/>
              <a:alpha val="2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8494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144</Words>
  <Application>Microsoft Macintosh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gle</dc:creator>
  <cp:lastModifiedBy>Katherine Denby</cp:lastModifiedBy>
  <cp:revision>32</cp:revision>
  <dcterms:created xsi:type="dcterms:W3CDTF">2014-07-25T11:29:17Z</dcterms:created>
  <dcterms:modified xsi:type="dcterms:W3CDTF">2015-09-16T19:53:40Z</dcterms:modified>
</cp:coreProperties>
</file>